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41EB37-1B4B-458C-8A4E-CFC50A5085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0A666D-40CA-4E10-B613-B0C4EDED24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F1BC43-612E-4B64-A45A-9941C790927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BE90B-1097-4DF4-9CF4-A186A8AE86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1F671F-0215-4ECA-97A8-D7D50795A3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7D3F01-F76E-40F4-96B6-CECA1B74A4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5BF16A-EE56-4A76-91EB-BF8FB4D110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EB8F22-F273-4259-8ED4-2FEC136090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7E656B-B0EF-47B9-ABF1-FF648B378D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6D5AE-A88C-42D4-85A5-70903A739F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6B225-8417-4122-ABD8-6D07E5AF94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FF4960-FAB3-4A42-8A0F-D58F76C3A3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EC9DE5B-FAEA-4E01-B712-3702EDC1ED14}" type="slidenum">
              <a:rPr b="0" lang="en-AU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/>
          </p:nvPr>
        </p:nvSpPr>
        <p:spPr>
          <a:xfrm>
            <a:off x="1627200" y="1042920"/>
            <a:ext cx="3457440" cy="4105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tIns="90000" anchor="t" anchorCtr="1">
            <a:normAutofit fontScale="94000"/>
          </a:bodyPr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iR159 target : U21_3667 (GAMY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                </a:t>
            </a:r>
            <a:r>
              <a:rPr b="1" lang="en-AU" sz="12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4/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            ↓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AAGATGGAGCTCCCT</a:t>
            </a:r>
            <a:r>
              <a:rPr b="1" lang="en-AU" sz="1200" spc="-1" strike="noStrike">
                <a:solidFill>
                  <a:srgbClr val="008000"/>
                </a:solidFill>
                <a:latin typeface="Courier New"/>
                <a:ea typeface="Times New Roman"/>
              </a:rPr>
              <a:t>T</a:t>
            </a:r>
            <a:r>
              <a:rPr b="0" lang="en-AU" sz="12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ACTCCAAGATACC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iR156 target : U21_18637 (SP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ff3300"/>
                </a:solidFill>
                <a:latin typeface="Courier New"/>
                <a:ea typeface="Times New Roman"/>
              </a:rPr>
              <a:t>                </a:t>
            </a:r>
            <a:r>
              <a:rPr b="1" lang="en-AU" sz="1200" spc="-1" strike="noStrike">
                <a:solidFill>
                  <a:srgbClr val="ff3300"/>
                </a:solidFill>
                <a:latin typeface="Courier New"/>
                <a:ea typeface="Times New Roman"/>
              </a:rPr>
              <a:t>3/4</a:t>
            </a:r>
            <a:r>
              <a:rPr b="0" lang="en-AU" sz="1200" spc="-1" strike="noStrike">
                <a:solidFill>
                  <a:srgbClr val="3366ff"/>
                </a:solidFill>
                <a:latin typeface="Courier New"/>
                <a:ea typeface="Times New Roman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            ↓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GGACTGTGCTCTCTC</a:t>
            </a:r>
            <a:r>
              <a:rPr b="1" lang="en-AU" sz="1200" spc="-1" strike="noStrike">
                <a:solidFill>
                  <a:srgbClr val="008000"/>
                </a:solidFill>
                <a:latin typeface="Courier New"/>
                <a:ea typeface="Times New Roman"/>
              </a:rPr>
              <a:t>T</a:t>
            </a:r>
            <a:r>
              <a:rPr b="0" lang="en-AU" sz="12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TTCTGTCAGCTCC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iR164 target : U21_9757 (NA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                </a:t>
            </a:r>
            <a:r>
              <a:rPr b="1" lang="en-AU" sz="12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2/3 1/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            ↓   ↓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GCGGCGCACGTGACC</a:t>
            </a:r>
            <a:r>
              <a:rPr b="1" lang="en-AU" sz="1200" spc="-1" strike="noStrike">
                <a:solidFill>
                  <a:srgbClr val="008000"/>
                </a:solidFill>
                <a:latin typeface="Courier New"/>
                <a:ea typeface="Times New Roman"/>
              </a:rPr>
              <a:t>T</a:t>
            </a:r>
            <a:r>
              <a:rPr b="0" lang="en-AU" sz="12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CTTCTCCAACAAC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22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6"/>
          <p:cNvSpPr/>
          <p:nvPr/>
        </p:nvSpPr>
        <p:spPr>
          <a:xfrm>
            <a:off x="404640" y="5796000"/>
            <a:ext cx="61200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000" spc="-1" strike="noStrike">
                <a:solidFill>
                  <a:srgbClr val="000000"/>
                </a:solidFill>
                <a:latin typeface="Arial"/>
              </a:rPr>
              <a:t>Figure S5: Results of RLM-5</a:t>
            </a:r>
            <a:r>
              <a:rPr b="1" lang="ja-JP" sz="1000" spc="-1" strike="noStrike">
                <a:solidFill>
                  <a:srgbClr val="000000"/>
                </a:solidFill>
                <a:latin typeface="Arial"/>
              </a:rPr>
              <a:t>’</a:t>
            </a:r>
            <a:r>
              <a:rPr b="1" lang="en-AU" sz="1000" spc="-1" strike="noStrike">
                <a:solidFill>
                  <a:srgbClr val="000000"/>
                </a:solidFill>
                <a:latin typeface="Arial"/>
              </a:rPr>
              <a:t>RACE for three targets of known miRNAs 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The sequences correspond to the 36 bp TSS of each target, the base in green shows the 5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’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end position of the corresponding degradome signature. Numbers in red refer the ratio of 5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’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-RACE clones matching the site indicated by an arrow over the total number of clones sequence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AutoShape 7"/>
          <p:cNvSpPr/>
          <p:nvPr/>
        </p:nvSpPr>
        <p:spPr>
          <a:xfrm>
            <a:off x="1339920" y="826920"/>
            <a:ext cx="3960720" cy="4608720"/>
          </a:xfrm>
          <a:custGeom>
            <a:avLst/>
            <a:gdLst>
              <a:gd name="textAreaLeft" fmla="*/ 193320 w 3960720"/>
              <a:gd name="textAreaRight" fmla="*/ 3767400 w 3960720"/>
              <a:gd name="textAreaTop" fmla="*/ 193320 h 4608720"/>
              <a:gd name="textAreaBottom" fmla="*/ 4415400 h 4608720"/>
            </a:gdLst>
            <a:ahLst/>
            <a:rect l="textAreaLeft" t="textAreaTop" r="textAreaRight" b="textAreaBottom"/>
            <a:pathLst>
              <a:path w="21600" h="25134">
                <a:moveTo>
                  <a:pt x="3600" y="0"/>
                </a:moveTo>
                <a:arcTo wR="3600" hR="3600" stAng="16200000" swAng="-5400000"/>
                <a:lnTo>
                  <a:pt x="0" y="21534"/>
                </a:lnTo>
                <a:arcTo wR="3600" hR="3600" stAng="10800000" swAng="-5400000"/>
                <a:lnTo>
                  <a:pt x="18000" y="25134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06T08:11:18Z</dcterms:created>
  <dc:creator>Curaba, Julien (PI, Black Mountain)</dc:creator>
  <dc:description/>
  <dc:language>en-US</dc:language>
  <cp:lastModifiedBy>hel046</cp:lastModifiedBy>
  <dcterms:modified xsi:type="dcterms:W3CDTF">2012-05-17T07:16:27Z</dcterms:modified>
  <cp:revision>159</cp:revision>
  <dc:subject/>
  <dc:title>Slide 1</dc:title>
</cp:coreProperties>
</file>